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058400" cy="7772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A4FAA-2702-4231-873F-67EFD8D5AF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8DAF9-EB2E-4B87-B312-4A63E1845E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B5995-0E7B-44FC-ADDB-79DFD02BCE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6F893-D315-4E8D-B839-531BD3A579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E641FC-5952-49B5-B064-C6F47F0BB4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F9EF8-D1F6-4045-AC8F-1A0449BF6A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08D25-F280-4864-B798-3B3FB9F287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B2F37-59F4-4F01-AE4A-8DEBE70908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7D520-9377-4767-975B-BF1E24A351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C2D5C6-D8FB-4DA1-A814-232EAF0EAE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83F148-9A12-45FE-A33F-E7DCF0A301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DE1E7-42D9-4796-B5FC-9419A158BD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DFE66A-E9A1-4024-8CC7-32D92E5562D2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55680" y="279360"/>
            <a:ext cx="9360000" cy="550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Figure S5.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mino acid sequence alignment of Cucumis melo CmACD3 (MELO3C003735P2a) with closely related sequences of of other plants.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7569360" y="7188120"/>
            <a:ext cx="2425680" cy="520920"/>
          </a:xfrm>
          <a:prstGeom prst="rect">
            <a:avLst/>
          </a:prstGeom>
          <a:ln w="0">
            <a:noFill/>
          </a:ln>
        </p:spPr>
      </p:pic>
      <p:grpSp>
        <p:nvGrpSpPr>
          <p:cNvPr id="43" name=""/>
          <p:cNvGrpSpPr/>
          <p:nvPr/>
        </p:nvGrpSpPr>
        <p:grpSpPr>
          <a:xfrm>
            <a:off x="1828800" y="1006920"/>
            <a:ext cx="6264000" cy="2355480"/>
            <a:chOff x="1828800" y="1006920"/>
            <a:chExt cx="6264000" cy="2355480"/>
          </a:xfrm>
        </p:grpSpPr>
        <p:pic>
          <p:nvPicPr>
            <p:cNvPr id="44" name="" descr=""/>
            <p:cNvPicPr/>
            <p:nvPr/>
          </p:nvPicPr>
          <p:blipFill>
            <a:blip r:embed="rId2"/>
            <a:stretch/>
          </p:blipFill>
          <p:spPr>
            <a:xfrm>
              <a:off x="1828800" y="1041480"/>
              <a:ext cx="6261480" cy="100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3"/>
            <a:stretch/>
          </p:blipFill>
          <p:spPr>
            <a:xfrm>
              <a:off x="1828800" y="2044800"/>
              <a:ext cx="6261480" cy="1002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5646600" y="1014480"/>
              <a:ext cx="196560" cy="397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320" bIns="3132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139520" y="1006920"/>
              <a:ext cx="196560" cy="397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320" bIns="3132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976920" y="2102040"/>
              <a:ext cx="23760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040" rIns="59040" tIns="29520" bIns="295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214880" y="2102040"/>
              <a:ext cx="23616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040" rIns="59040" tIns="29520" bIns="295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392360" y="2102040"/>
              <a:ext cx="23832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040" rIns="59040" tIns="29520" bIns="295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930920" y="2102040"/>
              <a:ext cx="23760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040" rIns="59040" tIns="29520" bIns="295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7138800" y="1099080"/>
              <a:ext cx="596520" cy="100296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306520" y="2130840"/>
              <a:ext cx="352800" cy="97380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260520" y="2102040"/>
              <a:ext cx="1850040" cy="100260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559320" y="3133800"/>
              <a:ext cx="119160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2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949400" y="3134160"/>
              <a:ext cx="119232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1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899400" y="2073240"/>
              <a:ext cx="119340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1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667480" y="104148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726160" y="112716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788440" y="112716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964120" y="112716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664600" y="2014920"/>
              <a:ext cx="15120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8600" rIns="4860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785560" y="2014920"/>
              <a:ext cx="15120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8600" rIns="4860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7157160" y="2014920"/>
              <a:ext cx="15120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8600" rIns="4860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696120" y="3018240"/>
              <a:ext cx="15120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8600" rIns="4860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" name=""/>
          <p:cNvGrpSpPr/>
          <p:nvPr/>
        </p:nvGrpSpPr>
        <p:grpSpPr>
          <a:xfrm>
            <a:off x="1828800" y="3353040"/>
            <a:ext cx="6264360" cy="2150640"/>
            <a:chOff x="1828800" y="3353040"/>
            <a:chExt cx="6264360" cy="2150640"/>
          </a:xfrm>
        </p:grpSpPr>
        <p:pic>
          <p:nvPicPr>
            <p:cNvPr id="67" name="" descr=""/>
            <p:cNvPicPr/>
            <p:nvPr/>
          </p:nvPicPr>
          <p:blipFill>
            <a:blip r:embed="rId4"/>
            <a:stretch/>
          </p:blipFill>
          <p:spPr>
            <a:xfrm>
              <a:off x="1887120" y="3388680"/>
              <a:ext cx="6206040" cy="993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" descr=""/>
            <p:cNvPicPr/>
            <p:nvPr/>
          </p:nvPicPr>
          <p:blipFill>
            <a:blip r:embed="rId5"/>
            <a:stretch/>
          </p:blipFill>
          <p:spPr>
            <a:xfrm>
              <a:off x="1828800" y="4382280"/>
              <a:ext cx="6205320" cy="993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"/>
            <p:cNvSpPr/>
            <p:nvPr/>
          </p:nvSpPr>
          <p:spPr>
            <a:xfrm>
              <a:off x="3070440" y="3353040"/>
              <a:ext cx="194760" cy="39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2280" rIns="62280" tIns="30960" bIns="3096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090600" y="33886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385800" y="34747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863600" y="344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924080" y="344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982760" y="344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041440" y="344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101920" y="344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160600" y="344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401880" y="344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460920" y="344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757560" y="344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556720" y="44668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858480" y="44398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917520" y="44398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036680" y="44398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395680" y="44398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455800" y="44398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052760" y="44668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7111440" y="44668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7169040" y="44668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903200" y="3416760"/>
              <a:ext cx="413640" cy="99396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370400" y="4411440"/>
              <a:ext cx="1299600" cy="37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4880" rIns="74880" tIns="37440" bIns="37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NADPH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146040" y="4383000"/>
              <a:ext cx="14976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880" rIns="4788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7165800" y="5348520"/>
              <a:ext cx="14976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880" rIns="4788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4" name="" descr=""/>
          <p:cNvPicPr/>
          <p:nvPr/>
        </p:nvPicPr>
        <p:blipFill>
          <a:blip r:embed="rId6"/>
          <a:stretch/>
        </p:blipFill>
        <p:spPr>
          <a:xfrm>
            <a:off x="1828800" y="5562720"/>
            <a:ext cx="7558200" cy="920520"/>
          </a:xfrm>
          <a:prstGeom prst="rect">
            <a:avLst/>
          </a:prstGeom>
          <a:ln w="0">
            <a:noFill/>
          </a:ln>
        </p:spPr>
      </p:pic>
      <p:sp>
        <p:nvSpPr>
          <p:cNvPr id="95" name=""/>
          <p:cNvSpPr/>
          <p:nvPr/>
        </p:nvSpPr>
        <p:spPr>
          <a:xfrm>
            <a:off x="0" y="-162072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0" y="296388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0" y="720252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623120" y="9119520"/>
            <a:ext cx="81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Figure.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C SYSTEM</cp:lastModifiedBy>
  <dcterms:modified xsi:type="dcterms:W3CDTF">2014-01-28T03:48:52Z</dcterms:modified>
  <cp:revision>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